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50403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97" autoAdjust="0"/>
    <p:restoredTop sz="94660"/>
  </p:normalViewPr>
  <p:slideViewPr>
    <p:cSldViewPr snapToGrid="0">
      <p:cViewPr>
        <p:scale>
          <a:sx n="196" d="100"/>
          <a:sy n="196" d="100"/>
        </p:scale>
        <p:origin x="749" y="-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kumimoji="1" lang="en-US" altLang="ja-JP" smtClean="0"/>
              <a:t>Ingesting yogurt containing Lactobacillus plantarum OLL2712 reduces abdominal fat accumulation and chronic inflammation in overweight adults in a randomized placebo-controlled trial, Toshimitsu et al., Online Supplementary Material.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0FF1DB-0361-40E1-8376-879385FBD93F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33B228-99A7-4A53-82FB-87FB1B7F15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3113108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kumimoji="1" lang="en-US" altLang="ja-JP" smtClean="0"/>
              <a:t>Ingesting yogurt containing Lactobacillus plantarum OLL2712 reduces abdominal fat accumulation and chronic inflammation in overweight adults in a randomized placebo-controlled trial, Toshimitsu et al., Online Supplementary Material.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EB37B6-AFC9-4E1E-A318-ECF49466629A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46338" y="1143000"/>
            <a:ext cx="1965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A6D98-F93C-49F0-9E42-3C170A6D0D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329020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1pPr>
    <a:lvl2pPr marL="14745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2pPr>
    <a:lvl3pPr marL="29490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3pPr>
    <a:lvl4pPr marL="442353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4pPr>
    <a:lvl5pPr marL="58980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5pPr>
    <a:lvl6pPr marL="73725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6pPr>
    <a:lvl7pPr marL="884706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7pPr>
    <a:lvl8pPr marL="103215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8pPr>
    <a:lvl9pPr marL="117960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296173"/>
            <a:ext cx="4284266" cy="2757347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4159854"/>
            <a:ext cx="3780235" cy="1912175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800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385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421669"/>
            <a:ext cx="1086817" cy="671186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421669"/>
            <a:ext cx="3197449" cy="671186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6538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7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974512"/>
            <a:ext cx="4347270" cy="3294515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5300194"/>
            <a:ext cx="4347270" cy="1732508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/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73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2108344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2108344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2793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21671"/>
            <a:ext cx="4347270" cy="153084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941510"/>
            <a:ext cx="2132288" cy="951504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893014"/>
            <a:ext cx="2132288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941510"/>
            <a:ext cx="2142790" cy="951504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893014"/>
            <a:ext cx="2142790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102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235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931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2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1140341"/>
            <a:ext cx="2551658" cy="5628360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125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2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1140341"/>
            <a:ext cx="2551658" cy="5628360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66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421671"/>
            <a:ext cx="434727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2108344"/>
            <a:ext cx="434727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7340703"/>
            <a:ext cx="113407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7340703"/>
            <a:ext cx="1701106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7340703"/>
            <a:ext cx="113407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73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kumimoji="1"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5151" y="502025"/>
            <a:ext cx="2601900" cy="2079000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6520" y="2728558"/>
            <a:ext cx="4456026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ja-JP" altLang="ja-JP" sz="700" b="1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ja-JP" sz="7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FIGURE </a:t>
            </a:r>
            <a:r>
              <a:rPr lang="en-US" altLang="ja-JP" sz="7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3  </a:t>
            </a:r>
            <a:r>
              <a:rPr lang="ja-JP" altLang="ja-JP" sz="700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attern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of change in</a:t>
            </a:r>
            <a:r>
              <a:rPr lang="en-US" altLang="ja-JP" sz="700" kern="100" dirty="0">
                <a:solidFill>
                  <a:srgbClr val="FF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s</a:t>
            </a:r>
            <a:r>
              <a:rPr lang="ja-JP" altLang="ja-JP" sz="700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bgroup analysis of fasting plasma glucose </a:t>
            </a:r>
            <a:r>
              <a:rPr lang="ja-JP" altLang="ja-JP" sz="700" kern="100" dirty="0" smtClean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at </a:t>
            </a:r>
            <a:r>
              <a:rPr lang="ja-JP" altLang="ja-JP" sz="700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cluded participants with fasting plasma glucose </a:t>
            </a:r>
            <a:r>
              <a:rPr lang="en-US" altLang="ja-JP" sz="700" dirty="0">
                <a:latin typeface="Times New Roman" panose="02020603050405020304" pitchFamily="18" charset="0"/>
                <a:ea typeface="平成明朝"/>
              </a:rPr>
              <a:t>concentrations</a:t>
            </a:r>
            <a:r>
              <a:rPr lang="ja-JP" altLang="ja-JP" sz="700" kern="100" dirty="0" smtClean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ja-JP" sz="700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low 80 mg/dL at </a:t>
            </a:r>
            <a:r>
              <a:rPr lang="ja-JP" altLang="ja-JP" sz="700" kern="100" dirty="0" smtClean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line</a:t>
            </a:r>
            <a:r>
              <a:rPr lang="ja-JP" altLang="en-US" sz="700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00" dirty="0">
                <a:latin typeface="Times New Roman" panose="02020603050405020304" pitchFamily="18" charset="0"/>
                <a:ea typeface="平成明朝"/>
              </a:rPr>
              <a:t>in overweight adults who consumed OLL2712 or placebo yogurt for 12 </a:t>
            </a:r>
            <a:r>
              <a:rPr lang="en-US" altLang="ja-JP" sz="700" dirty="0" smtClean="0">
                <a:latin typeface="Times New Roman" panose="02020603050405020304" pitchFamily="18" charset="0"/>
                <a:ea typeface="平成明朝"/>
              </a:rPr>
              <a:t>wk.</a:t>
            </a:r>
          </a:p>
          <a:p>
            <a:pPr algn="just"/>
            <a:r>
              <a:rPr lang="en-US" altLang="ja-JP" sz="700" dirty="0" smtClean="0">
                <a:latin typeface="Times New Roman" panose="02020603050405020304" pitchFamily="18" charset="0"/>
                <a:ea typeface="平成明朝"/>
              </a:rPr>
              <a:t>Values are means ± SE.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00" i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n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= 32 in the placebo group and </a:t>
            </a:r>
            <a:r>
              <a:rPr lang="en-US" altLang="ja-JP" sz="700" i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n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= 43 in the OLL2712 group.</a:t>
            </a:r>
            <a:endParaRPr lang="en-US" altLang="ja-JP" sz="700" dirty="0" smtClean="0">
              <a:latin typeface="Times New Roman" panose="02020603050405020304" pitchFamily="18" charset="0"/>
              <a:ea typeface="平成明朝"/>
            </a:endParaRPr>
          </a:p>
          <a:p>
            <a:pPr algn="just">
              <a:spcAft>
                <a:spcPts val="0"/>
              </a:spcAft>
            </a:pP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Significant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differences in measurements compared 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with 0 </a:t>
            </a:r>
            <a:r>
              <a:rPr lang="en-US" altLang="ja-JP" sz="700" kern="1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wk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were determined using the Wilcoxon signed-rank tests 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(</a:t>
            </a:r>
            <a:r>
              <a:rPr lang="en-US" altLang="ja-JP" sz="700" kern="1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*</a:t>
            </a:r>
            <a:r>
              <a:rPr lang="en-US" altLang="ja-JP" sz="7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P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&lt; 0.05). Significant differences in measurements compared 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with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the placebo group were determined using the 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Mann</a:t>
            </a:r>
            <a:r>
              <a:rPr lang="en-US" altLang="ja-JP" sz="700" b="1" dirty="0">
                <a:latin typeface="Times New Roman" panose="02020603050405020304" pitchFamily="18" charset="0"/>
                <a:ea typeface="平成明朝"/>
              </a:rPr>
              <a:t>–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Whitney 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U tests (</a:t>
            </a:r>
            <a:r>
              <a:rPr lang="en-US" altLang="ja-JP" sz="7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#</a:t>
            </a:r>
            <a:r>
              <a:rPr lang="en-US" altLang="ja-JP" sz="7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P</a:t>
            </a:r>
            <a:r>
              <a:rPr lang="en-US" altLang="ja-JP" sz="700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&lt; 0.05). </a:t>
            </a:r>
            <a:endParaRPr lang="ja-JP" altLang="ja-JP" sz="700" kern="100" dirty="0">
              <a:solidFill>
                <a:srgbClr val="000000"/>
              </a:solidFill>
              <a:effectLst/>
              <a:latin typeface="Times" panose="02020603050405020304" pitchFamily="18" charset="0"/>
              <a:ea typeface="平成明朝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2"/>
          <p:cNvSpPr txBox="1"/>
          <p:nvPr/>
        </p:nvSpPr>
        <p:spPr>
          <a:xfrm>
            <a:off x="2155768" y="942832"/>
            <a:ext cx="261042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pPr>
              <a:spcAft>
                <a:spcPts val="0"/>
              </a:spcAft>
            </a:pPr>
            <a:r>
              <a:rPr lang="en-US" sz="700" b="1" baseline="300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</a:t>
            </a:r>
            <a:endParaRPr lang="ja-JP" sz="700" baseline="30000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4" name="テキスト ボックス 2"/>
          <p:cNvSpPr txBox="1"/>
          <p:nvPr/>
        </p:nvSpPr>
        <p:spPr>
          <a:xfrm>
            <a:off x="2665916" y="1894828"/>
            <a:ext cx="19685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pPr>
              <a:spcAft>
                <a:spcPts val="0"/>
              </a:spcAft>
            </a:pPr>
            <a:r>
              <a:rPr lang="en-US" sz="7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sz="700" baseline="30000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20" name="テキスト ボックス 2"/>
          <p:cNvSpPr txBox="1"/>
          <p:nvPr/>
        </p:nvSpPr>
        <p:spPr>
          <a:xfrm>
            <a:off x="2164820" y="1701688"/>
            <a:ext cx="19685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pPr>
              <a:spcAft>
                <a:spcPts val="0"/>
              </a:spcAft>
            </a:pPr>
            <a:r>
              <a:rPr lang="en-US" sz="7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sz="700" baseline="30000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5241" y="8861"/>
            <a:ext cx="49682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esting yogurt containing 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ja-JP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LL2712 reduces abdominal fat accumulation and chronic inflammation in overweight adults in a randomized placebo-controlled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sz="700" kern="1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Toshimitsu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sz="700" i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et 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., Online Supplementary Material.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5396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</TotalTime>
  <Words>138</Words>
  <Application>Microsoft Office PowerPoint</Application>
  <PresentationFormat>ユーザー設定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0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2" baseType="lpstr">
      <vt:lpstr>ＭＳ Ｐゴシック</vt:lpstr>
      <vt:lpstr>ＭＳ ゴシック</vt:lpstr>
      <vt:lpstr>平成明朝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</vt:vector>
  </TitlesOfParts>
  <Company>明治グループ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利光　孝之</dc:creator>
  <cp:lastModifiedBy>利光　孝之</cp:lastModifiedBy>
  <cp:revision>28</cp:revision>
  <dcterms:created xsi:type="dcterms:W3CDTF">2020-06-02T06:38:14Z</dcterms:created>
  <dcterms:modified xsi:type="dcterms:W3CDTF">2021-01-01T02:28:32Z</dcterms:modified>
</cp:coreProperties>
</file>